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E4096"/>
    <a:srgbClr val="FE0A78"/>
    <a:srgbClr val="3E69FD"/>
    <a:srgbClr val="FE64A9"/>
    <a:srgbClr val="FF64AA"/>
    <a:srgbClr val="0F42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10EBEEC-C0A3-8445-8585-5FE01254B699}" v="2" dt="2023-12-19T18:46:42.764"/>
    <p1510:client id="{AF4E92C1-E9B2-D248-998A-319F3405BBDC}" v="12" dt="2023-12-20T18:21:17.389"/>
    <p1510:client id="{EF9D6E9C-F726-4512-A7AC-2DD8638EB16D}" v="2" dt="2023-12-20T16:41:37.75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6190"/>
  </p:normalViewPr>
  <p:slideViewPr>
    <p:cSldViewPr snapToGrid="0">
      <p:cViewPr>
        <p:scale>
          <a:sx n="273" d="100"/>
          <a:sy n="273" d="100"/>
        </p:scale>
        <p:origin x="-560" y="-57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esús Antonio Gómez Ochoa de Alda" userId="111346b4-2c77-4688-bb93-b1ed5af05578" providerId="ADAL" clId="{AF4E92C1-E9B2-D248-998A-319F3405BBDC}"/>
    <pc:docChg chg="undo custSel modSld">
      <pc:chgData name="Jesús Antonio Gómez Ochoa de Alda" userId="111346b4-2c77-4688-bb93-b1ed5af05578" providerId="ADAL" clId="{AF4E92C1-E9B2-D248-998A-319F3405BBDC}" dt="2023-12-20T17:07:59.284" v="276" actId="1038"/>
      <pc:docMkLst>
        <pc:docMk/>
      </pc:docMkLst>
      <pc:sldChg chg="addSp delSp modSp mod">
        <pc:chgData name="Jesús Antonio Gómez Ochoa de Alda" userId="111346b4-2c77-4688-bb93-b1ed5af05578" providerId="ADAL" clId="{AF4E92C1-E9B2-D248-998A-319F3405BBDC}" dt="2023-12-20T17:07:59.284" v="276" actId="1038"/>
        <pc:sldMkLst>
          <pc:docMk/>
          <pc:sldMk cId="695869370" sldId="281"/>
        </pc:sldMkLst>
        <pc:spChg chg="mod">
          <ac:chgData name="Jesús Antonio Gómez Ochoa de Alda" userId="111346b4-2c77-4688-bb93-b1ed5af05578" providerId="ADAL" clId="{AF4E92C1-E9B2-D248-998A-319F3405BBDC}" dt="2023-12-19T19:12:39.510" v="6" actId="1076"/>
          <ac:spMkLst>
            <pc:docMk/>
            <pc:sldMk cId="695869370" sldId="281"/>
            <ac:spMk id="6" creationId="{24642CFF-2D8D-9D4A-9B90-61208229C957}"/>
          </ac:spMkLst>
        </pc:spChg>
        <pc:picChg chg="add mod modCrop">
          <ac:chgData name="Jesús Antonio Gómez Ochoa de Alda" userId="111346b4-2c77-4688-bb93-b1ed5af05578" providerId="ADAL" clId="{AF4E92C1-E9B2-D248-998A-319F3405BBDC}" dt="2023-12-20T17:07:52.342" v="239" actId="1038"/>
          <ac:picMkLst>
            <pc:docMk/>
            <pc:sldMk cId="695869370" sldId="281"/>
            <ac:picMk id="4" creationId="{74F4D6B3-A0A6-46D9-B8E8-E0CCFB83119F}"/>
          </ac:picMkLst>
        </pc:picChg>
        <pc:picChg chg="add mod modCrop">
          <ac:chgData name="Jesús Antonio Gómez Ochoa de Alda" userId="111346b4-2c77-4688-bb93-b1ed5af05578" providerId="ADAL" clId="{AF4E92C1-E9B2-D248-998A-319F3405BBDC}" dt="2023-12-19T19:13:01.119" v="10" actId="1076"/>
          <ac:picMkLst>
            <pc:docMk/>
            <pc:sldMk cId="695869370" sldId="281"/>
            <ac:picMk id="7" creationId="{C963E6DC-5AC2-954B-7044-A2468A3FAA91}"/>
          </ac:picMkLst>
        </pc:picChg>
        <pc:picChg chg="add mod modCrop">
          <ac:chgData name="Jesús Antonio Gómez Ochoa de Alda" userId="111346b4-2c77-4688-bb93-b1ed5af05578" providerId="ADAL" clId="{AF4E92C1-E9B2-D248-998A-319F3405BBDC}" dt="2023-12-20T17:07:59.284" v="276" actId="1038"/>
          <ac:picMkLst>
            <pc:docMk/>
            <pc:sldMk cId="695869370" sldId="281"/>
            <ac:picMk id="8" creationId="{57B9B67C-A8D4-133B-831A-5A294DA2D889}"/>
          </ac:picMkLst>
        </pc:picChg>
        <pc:picChg chg="del">
          <ac:chgData name="Jesús Antonio Gómez Ochoa de Alda" userId="111346b4-2c77-4688-bb93-b1ed5af05578" providerId="ADAL" clId="{AF4E92C1-E9B2-D248-998A-319F3405BBDC}" dt="2023-12-19T19:12:28.635" v="3" actId="478"/>
          <ac:picMkLst>
            <pc:docMk/>
            <pc:sldMk cId="695869370" sldId="281"/>
            <ac:picMk id="13" creationId="{AC40C896-B08B-C14C-B939-D2389A8190A0}"/>
          </ac:picMkLst>
        </pc:picChg>
        <pc:picChg chg="del">
          <ac:chgData name="Jesús Antonio Gómez Ochoa de Alda" userId="111346b4-2c77-4688-bb93-b1ed5af05578" providerId="ADAL" clId="{AF4E92C1-E9B2-D248-998A-319F3405BBDC}" dt="2023-12-19T19:12:27.678" v="2" actId="478"/>
          <ac:picMkLst>
            <pc:docMk/>
            <pc:sldMk cId="695869370" sldId="281"/>
            <ac:picMk id="14" creationId="{D01E55A3-FE58-3F49-8916-70DF23F27C81}"/>
          </ac:picMkLst>
        </pc:picChg>
        <pc:cxnChg chg="del">
          <ac:chgData name="Jesús Antonio Gómez Ochoa de Alda" userId="111346b4-2c77-4688-bb93-b1ed5af05578" providerId="ADAL" clId="{AF4E92C1-E9B2-D248-998A-319F3405BBDC}" dt="2023-12-19T19:12:30.130" v="4" actId="478"/>
          <ac:cxnSpMkLst>
            <pc:docMk/>
            <pc:sldMk cId="695869370" sldId="281"/>
            <ac:cxnSpMk id="3" creationId="{76C90739-80B4-B532-A2FE-722F2D076317}"/>
          </ac:cxnSpMkLst>
        </pc:cxnChg>
      </pc:sldChg>
    </pc:docChg>
  </pc:docChgLst>
  <pc:docChgLst>
    <pc:chgData name="Jesús Antonio Gómez Ochoa de Alda" userId="111346b4-2c77-4688-bb93-b1ed5af05578" providerId="ADAL" clId="{EF9D6E9C-F726-4512-A7AC-2DD8638EB16D}"/>
    <pc:docChg chg="custSel modSld">
      <pc:chgData name="Jesús Antonio Gómez Ochoa de Alda" userId="111346b4-2c77-4688-bb93-b1ed5af05578" providerId="ADAL" clId="{EF9D6E9C-F726-4512-A7AC-2DD8638EB16D}" dt="2023-12-20T16:41:48.472" v="188" actId="478"/>
      <pc:docMkLst>
        <pc:docMk/>
      </pc:docMkLst>
      <pc:sldChg chg="addSp delSp modSp mod">
        <pc:chgData name="Jesús Antonio Gómez Ochoa de Alda" userId="111346b4-2c77-4688-bb93-b1ed5af05578" providerId="ADAL" clId="{EF9D6E9C-F726-4512-A7AC-2DD8638EB16D}" dt="2023-12-20T16:41:48.472" v="188" actId="478"/>
        <pc:sldMkLst>
          <pc:docMk/>
          <pc:sldMk cId="695869370" sldId="281"/>
        </pc:sldMkLst>
        <pc:spChg chg="add mod">
          <ac:chgData name="Jesús Antonio Gómez Ochoa de Alda" userId="111346b4-2c77-4688-bb93-b1ed5af05578" providerId="ADAL" clId="{EF9D6E9C-F726-4512-A7AC-2DD8638EB16D}" dt="2023-12-20T16:39:32.235" v="186" actId="20577"/>
          <ac:spMkLst>
            <pc:docMk/>
            <pc:sldMk cId="695869370" sldId="281"/>
            <ac:spMk id="2" creationId="{F53D2C43-7D58-60E7-3E3A-6C60AF1F369B}"/>
          </ac:spMkLst>
        </pc:spChg>
        <pc:spChg chg="mod">
          <ac:chgData name="Jesús Antonio Gómez Ochoa de Alda" userId="111346b4-2c77-4688-bb93-b1ed5af05578" providerId="ADAL" clId="{EF9D6E9C-F726-4512-A7AC-2DD8638EB16D}" dt="2023-12-20T16:38:32.871" v="38" actId="20577"/>
          <ac:spMkLst>
            <pc:docMk/>
            <pc:sldMk cId="695869370" sldId="281"/>
            <ac:spMk id="6" creationId="{24642CFF-2D8D-9D4A-9B90-61208229C957}"/>
          </ac:spMkLst>
        </pc:spChg>
        <pc:graphicFrameChg chg="add del mod">
          <ac:chgData name="Jesús Antonio Gómez Ochoa de Alda" userId="111346b4-2c77-4688-bb93-b1ed5af05578" providerId="ADAL" clId="{EF9D6E9C-F726-4512-A7AC-2DD8638EB16D}" dt="2023-12-20T16:41:48.472" v="188" actId="478"/>
          <ac:graphicFrameMkLst>
            <pc:docMk/>
            <pc:sldMk cId="695869370" sldId="281"/>
            <ac:graphicFrameMk id="3" creationId="{AA15A1C3-48CC-C639-6D5E-72D4B9703650}"/>
          </ac:graphicFrameMkLst>
        </pc:graphicFrameChg>
        <pc:picChg chg="del">
          <ac:chgData name="Jesús Antonio Gómez Ochoa de Alda" userId="111346b4-2c77-4688-bb93-b1ed5af05578" providerId="ADAL" clId="{EF9D6E9C-F726-4512-A7AC-2DD8638EB16D}" dt="2023-12-20T16:37:23.241" v="2" actId="478"/>
          <ac:picMkLst>
            <pc:docMk/>
            <pc:sldMk cId="695869370" sldId="281"/>
            <ac:picMk id="4" creationId="{A24C5FA8-C167-6830-F7BC-A624330E45DC}"/>
          </ac:picMkLst>
        </pc:picChg>
        <pc:picChg chg="del">
          <ac:chgData name="Jesús Antonio Gómez Ochoa de Alda" userId="111346b4-2c77-4688-bb93-b1ed5af05578" providerId="ADAL" clId="{EF9D6E9C-F726-4512-A7AC-2DD8638EB16D}" dt="2023-12-20T16:37:19.756" v="0" actId="478"/>
          <ac:picMkLst>
            <pc:docMk/>
            <pc:sldMk cId="695869370" sldId="281"/>
            <ac:picMk id="7" creationId="{C963E6DC-5AC2-954B-7044-A2468A3FAA91}"/>
          </ac:picMkLst>
        </pc:picChg>
        <pc:picChg chg="del">
          <ac:chgData name="Jesús Antonio Gómez Ochoa de Alda" userId="111346b4-2c77-4688-bb93-b1ed5af05578" providerId="ADAL" clId="{EF9D6E9C-F726-4512-A7AC-2DD8638EB16D}" dt="2023-12-20T16:37:21.122" v="1" actId="478"/>
          <ac:picMkLst>
            <pc:docMk/>
            <pc:sldMk cId="695869370" sldId="281"/>
            <ac:picMk id="8" creationId="{3FBA089F-BAA4-4F40-DEB6-A1B93A82628C}"/>
          </ac:picMkLst>
        </pc:picChg>
      </pc:sldChg>
    </pc:docChg>
  </pc:docChgLst>
  <pc:docChgLst>
    <pc:chgData name="Jesús Antonio Gómez Ochoa de Alda" userId="111346b4-2c77-4688-bb93-b1ed5af05578" providerId="ADAL" clId="{510EBEEC-C0A3-8445-8585-5FE01254B699}"/>
    <pc:docChg chg="modSld">
      <pc:chgData name="Jesús Antonio Gómez Ochoa de Alda" userId="111346b4-2c77-4688-bb93-b1ed5af05578" providerId="ADAL" clId="{510EBEEC-C0A3-8445-8585-5FE01254B699}" dt="2023-12-19T18:46:56.224" v="15" actId="14100"/>
      <pc:docMkLst>
        <pc:docMk/>
      </pc:docMkLst>
      <pc:sldChg chg="addSp modSp mod">
        <pc:chgData name="Jesús Antonio Gómez Ochoa de Alda" userId="111346b4-2c77-4688-bb93-b1ed5af05578" providerId="ADAL" clId="{510EBEEC-C0A3-8445-8585-5FE01254B699}" dt="2023-12-19T18:46:56.224" v="15" actId="14100"/>
        <pc:sldMkLst>
          <pc:docMk/>
          <pc:sldMk cId="695869370" sldId="281"/>
        </pc:sldMkLst>
        <pc:picChg chg="add mod">
          <ac:chgData name="Jesús Antonio Gómez Ochoa de Alda" userId="111346b4-2c77-4688-bb93-b1ed5af05578" providerId="ADAL" clId="{510EBEEC-C0A3-8445-8585-5FE01254B699}" dt="2023-12-19T18:46:39.511" v="9" actId="14100"/>
          <ac:picMkLst>
            <pc:docMk/>
            <pc:sldMk cId="695869370" sldId="281"/>
            <ac:picMk id="4" creationId="{A24C5FA8-C167-6830-F7BC-A624330E45DC}"/>
          </ac:picMkLst>
        </pc:picChg>
        <pc:picChg chg="add mod">
          <ac:chgData name="Jesús Antonio Gómez Ochoa de Alda" userId="111346b4-2c77-4688-bb93-b1ed5af05578" providerId="ADAL" clId="{510EBEEC-C0A3-8445-8585-5FE01254B699}" dt="2023-12-19T18:46:56.224" v="15" actId="14100"/>
          <ac:picMkLst>
            <pc:docMk/>
            <pc:sldMk cId="695869370" sldId="281"/>
            <ac:picMk id="8" creationId="{3FBA089F-BAA4-4F40-DEB6-A1B93A82628C}"/>
          </ac:picMkLst>
        </pc:picChg>
        <pc:cxnChg chg="add mod">
          <ac:chgData name="Jesús Antonio Gómez Ochoa de Alda" userId="111346b4-2c77-4688-bb93-b1ed5af05578" providerId="ADAL" clId="{510EBEEC-C0A3-8445-8585-5FE01254B699}" dt="2023-12-19T18:03:53.729" v="3" actId="14100"/>
          <ac:cxnSpMkLst>
            <pc:docMk/>
            <pc:sldMk cId="695869370" sldId="281"/>
            <ac:cxnSpMk id="3" creationId="{76C90739-80B4-B532-A2FE-722F2D076317}"/>
          </ac:cxnSpMkLst>
        </pc:cxnChg>
      </pc:sldChg>
    </pc:docChg>
  </pc:docChgLst>
  <pc:docChgLst>
    <pc:chgData name="JESÚS ANTONIO  GÓMEZ OCHOA DE ALDA" userId="111346b4-2c77-4688-bb93-b1ed5af05578" providerId="ADAL" clId="{AF4E92C1-E9B2-D248-998A-319F3405BBDC}"/>
    <pc:docChg chg="undo custSel modSld">
      <pc:chgData name="JESÚS ANTONIO  GÓMEZ OCHOA DE ALDA" userId="111346b4-2c77-4688-bb93-b1ed5af05578" providerId="ADAL" clId="{AF4E92C1-E9B2-D248-998A-319F3405BBDC}" dt="2023-12-20T18:21:46.957" v="476" actId="1076"/>
      <pc:docMkLst>
        <pc:docMk/>
      </pc:docMkLst>
      <pc:sldChg chg="addSp delSp modSp mod">
        <pc:chgData name="JESÚS ANTONIO  GÓMEZ OCHOA DE ALDA" userId="111346b4-2c77-4688-bb93-b1ed5af05578" providerId="ADAL" clId="{AF4E92C1-E9B2-D248-998A-319F3405BBDC}" dt="2023-12-20T18:21:46.957" v="476" actId="1076"/>
        <pc:sldMkLst>
          <pc:docMk/>
          <pc:sldMk cId="695869370" sldId="281"/>
        </pc:sldMkLst>
        <pc:spChg chg="mod">
          <ac:chgData name="JESÚS ANTONIO  GÓMEZ OCHOA DE ALDA" userId="111346b4-2c77-4688-bb93-b1ed5af05578" providerId="ADAL" clId="{AF4E92C1-E9B2-D248-998A-319F3405BBDC}" dt="2023-12-20T18:13:49.453" v="382" actId="313"/>
          <ac:spMkLst>
            <pc:docMk/>
            <pc:sldMk cId="695869370" sldId="281"/>
            <ac:spMk id="2" creationId="{F53D2C43-7D58-60E7-3E3A-6C60AF1F369B}"/>
          </ac:spMkLst>
        </pc:spChg>
        <pc:spChg chg="mod">
          <ac:chgData name="JESÚS ANTONIO  GÓMEZ OCHOA DE ALDA" userId="111346b4-2c77-4688-bb93-b1ed5af05578" providerId="ADAL" clId="{AF4E92C1-E9B2-D248-998A-319F3405BBDC}" dt="2023-12-20T18:10:35.880" v="289" actId="20577"/>
          <ac:spMkLst>
            <pc:docMk/>
            <pc:sldMk cId="695869370" sldId="281"/>
            <ac:spMk id="6" creationId="{24642CFF-2D8D-9D4A-9B90-61208229C957}"/>
          </ac:spMkLst>
        </pc:spChg>
        <pc:spChg chg="add mod">
          <ac:chgData name="JESÚS ANTONIO  GÓMEZ OCHOA DE ALDA" userId="111346b4-2c77-4688-bb93-b1ed5af05578" providerId="ADAL" clId="{AF4E92C1-E9B2-D248-998A-319F3405BBDC}" dt="2023-12-20T18:12:19.772" v="375" actId="20577"/>
          <ac:spMkLst>
            <pc:docMk/>
            <pc:sldMk cId="695869370" sldId="281"/>
            <ac:spMk id="13" creationId="{FFE56693-2EE3-FA32-0BBA-E24324F6AF4B}"/>
          </ac:spMkLst>
        </pc:spChg>
        <pc:spChg chg="add mod">
          <ac:chgData name="JESÚS ANTONIO  GÓMEZ OCHOA DE ALDA" userId="111346b4-2c77-4688-bb93-b1ed5af05578" providerId="ADAL" clId="{AF4E92C1-E9B2-D248-998A-319F3405BBDC}" dt="2023-12-20T18:12:15.205" v="374" actId="20577"/>
          <ac:spMkLst>
            <pc:docMk/>
            <pc:sldMk cId="695869370" sldId="281"/>
            <ac:spMk id="14" creationId="{1D672A1E-6049-5064-4429-766D508E20D3}"/>
          </ac:spMkLst>
        </pc:spChg>
        <pc:spChg chg="add mod">
          <ac:chgData name="JESÚS ANTONIO  GÓMEZ OCHOA DE ALDA" userId="111346b4-2c77-4688-bb93-b1ed5af05578" providerId="ADAL" clId="{AF4E92C1-E9B2-D248-998A-319F3405BBDC}" dt="2023-12-20T18:16:37.515" v="429" actId="1076"/>
          <ac:spMkLst>
            <pc:docMk/>
            <pc:sldMk cId="695869370" sldId="281"/>
            <ac:spMk id="15" creationId="{04F36B42-3214-628E-EB61-70A5E0586374}"/>
          </ac:spMkLst>
        </pc:spChg>
        <pc:spChg chg="add mod">
          <ac:chgData name="JESÚS ANTONIO  GÓMEZ OCHOA DE ALDA" userId="111346b4-2c77-4688-bb93-b1ed5af05578" providerId="ADAL" clId="{AF4E92C1-E9B2-D248-998A-319F3405BBDC}" dt="2023-12-20T18:20:52.869" v="455" actId="1076"/>
          <ac:spMkLst>
            <pc:docMk/>
            <pc:sldMk cId="695869370" sldId="281"/>
            <ac:spMk id="16" creationId="{06949C47-D98C-3AAA-8DFB-3D627B1E9859}"/>
          </ac:spMkLst>
        </pc:spChg>
        <pc:spChg chg="add mod">
          <ac:chgData name="JESÚS ANTONIO  GÓMEZ OCHOA DE ALDA" userId="111346b4-2c77-4688-bb93-b1ed5af05578" providerId="ADAL" clId="{AF4E92C1-E9B2-D248-998A-319F3405BBDC}" dt="2023-12-20T18:21:46.957" v="476" actId="1076"/>
          <ac:spMkLst>
            <pc:docMk/>
            <pc:sldMk cId="695869370" sldId="281"/>
            <ac:spMk id="17" creationId="{000B5D56-9B21-C60D-8298-9F6A40B2C0BE}"/>
          </ac:spMkLst>
        </pc:spChg>
        <pc:spChg chg="add mod">
          <ac:chgData name="JESÚS ANTONIO  GÓMEZ OCHOA DE ALDA" userId="111346b4-2c77-4688-bb93-b1ed5af05578" providerId="ADAL" clId="{AF4E92C1-E9B2-D248-998A-319F3405BBDC}" dt="2023-12-20T18:17:14.383" v="440" actId="1076"/>
          <ac:spMkLst>
            <pc:docMk/>
            <pc:sldMk cId="695869370" sldId="281"/>
            <ac:spMk id="18" creationId="{87CC1BB7-81D3-54B2-52AC-77FC56169175}"/>
          </ac:spMkLst>
        </pc:spChg>
        <pc:spChg chg="add mod">
          <ac:chgData name="JESÚS ANTONIO  GÓMEZ OCHOA DE ALDA" userId="111346b4-2c77-4688-bb93-b1ed5af05578" providerId="ADAL" clId="{AF4E92C1-E9B2-D248-998A-319F3405BBDC}" dt="2023-12-20T18:21:13.281" v="459" actId="20577"/>
          <ac:spMkLst>
            <pc:docMk/>
            <pc:sldMk cId="695869370" sldId="281"/>
            <ac:spMk id="19" creationId="{667D557C-4E50-0F83-8584-F264F0D6CD51}"/>
          </ac:spMkLst>
        </pc:spChg>
        <pc:spChg chg="add mod">
          <ac:chgData name="JESÚS ANTONIO  GÓMEZ OCHOA DE ALDA" userId="111346b4-2c77-4688-bb93-b1ed5af05578" providerId="ADAL" clId="{AF4E92C1-E9B2-D248-998A-319F3405BBDC}" dt="2023-12-20T18:21:31.273" v="463" actId="14100"/>
          <ac:spMkLst>
            <pc:docMk/>
            <pc:sldMk cId="695869370" sldId="281"/>
            <ac:spMk id="20" creationId="{54D5ABEC-82AF-181B-E5B9-FE062AF8E8A4}"/>
          </ac:spMkLst>
        </pc:spChg>
        <pc:picChg chg="del">
          <ac:chgData name="JESÚS ANTONIO  GÓMEZ OCHOA DE ALDA" userId="111346b4-2c77-4688-bb93-b1ed5af05578" providerId="ADAL" clId="{AF4E92C1-E9B2-D248-998A-319F3405BBDC}" dt="2023-12-20T18:07:53.497" v="0" actId="478"/>
          <ac:picMkLst>
            <pc:docMk/>
            <pc:sldMk cId="695869370" sldId="281"/>
            <ac:picMk id="4" creationId="{74F4D6B3-A0A6-46D9-B8E8-E0CCFB83119F}"/>
          </ac:picMkLst>
        </pc:picChg>
        <pc:picChg chg="add mod modCrop">
          <ac:chgData name="JESÚS ANTONIO  GÓMEZ OCHOA DE ALDA" userId="111346b4-2c77-4688-bb93-b1ed5af05578" providerId="ADAL" clId="{AF4E92C1-E9B2-D248-998A-319F3405BBDC}" dt="2023-12-20T18:21:43.144" v="475" actId="1038"/>
          <ac:picMkLst>
            <pc:docMk/>
            <pc:sldMk cId="695869370" sldId="281"/>
            <ac:picMk id="7" creationId="{2468E2D2-384C-E886-FF74-1FB4D81419E9}"/>
          </ac:picMkLst>
        </pc:picChg>
        <pc:picChg chg="del">
          <ac:chgData name="JESÚS ANTONIO  GÓMEZ OCHOA DE ALDA" userId="111346b4-2c77-4688-bb93-b1ed5af05578" providerId="ADAL" clId="{AF4E92C1-E9B2-D248-998A-319F3405BBDC}" dt="2023-12-20T18:07:54.270" v="1" actId="478"/>
          <ac:picMkLst>
            <pc:docMk/>
            <pc:sldMk cId="695869370" sldId="281"/>
            <ac:picMk id="8" creationId="{57B9B67C-A8D4-133B-831A-5A294DA2D889}"/>
          </ac:picMkLst>
        </pc:picChg>
        <pc:picChg chg="add mod modCrop">
          <ac:chgData name="JESÚS ANTONIO  GÓMEZ OCHOA DE ALDA" userId="111346b4-2c77-4688-bb93-b1ed5af05578" providerId="ADAL" clId="{AF4E92C1-E9B2-D248-998A-319F3405BBDC}" dt="2023-12-20T18:10:19.754" v="286" actId="1038"/>
          <ac:picMkLst>
            <pc:docMk/>
            <pc:sldMk cId="695869370" sldId="281"/>
            <ac:picMk id="10" creationId="{74B0E644-0E01-D516-03A6-164337A9195A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9831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5821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3255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3273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2585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739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466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0501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9121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9371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6088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2842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7FC76A53-08B9-164D-9E3C-DB555EA4E629}"/>
              </a:ext>
            </a:extLst>
          </p:cNvPr>
          <p:cNvSpPr txBox="1"/>
          <p:nvPr/>
        </p:nvSpPr>
        <p:spPr>
          <a:xfrm>
            <a:off x="1220763" y="742667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51D1198C-A6B1-A040-97B7-DCF9C577E158}"/>
              </a:ext>
            </a:extLst>
          </p:cNvPr>
          <p:cNvSpPr txBox="1"/>
          <p:nvPr/>
        </p:nvSpPr>
        <p:spPr>
          <a:xfrm>
            <a:off x="3623842" y="742667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24642CFF-2D8D-9D4A-9B90-61208229C957}"/>
              </a:ext>
            </a:extLst>
          </p:cNvPr>
          <p:cNvSpPr txBox="1"/>
          <p:nvPr/>
        </p:nvSpPr>
        <p:spPr>
          <a:xfrm>
            <a:off x="815902" y="4263378"/>
            <a:ext cx="524975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es-ES" sz="10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roducibility</a:t>
            </a:r>
            <a:r>
              <a:rPr lang="es-ES" sz="10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0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es-ES" sz="10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licates</a:t>
            </a:r>
            <a:r>
              <a:rPr lang="es-ES" sz="10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0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xoproteome</a:t>
            </a:r>
            <a:r>
              <a:rPr lang="es-ES" sz="10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aracterization</a:t>
            </a:r>
            <a:r>
              <a:rPr lang="es-ES" sz="10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catter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lots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rmalized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tein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tensities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log2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ansformed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licates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000" b="0" i="1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nabaena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PCC7120 (WT) (A) and </a:t>
            </a:r>
            <a:r>
              <a:rPr lang="el-GR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s-ES" sz="1000" b="0" i="1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zur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B).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earson’s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efficient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0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s-ES" sz="1000" b="0" u="none" strike="noStrike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nderlying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figure can be </a:t>
            </a:r>
            <a:r>
              <a:rPr lang="es-ES" sz="10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und</a:t>
            </a:r>
            <a:r>
              <a:rPr lang="es-ES" sz="10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n S1_Data.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2468E2D2-384C-E886-FF74-1FB4D81419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3" t="55673" r="66775" b="21357"/>
          <a:stretch/>
        </p:blipFill>
        <p:spPr>
          <a:xfrm>
            <a:off x="958086" y="1321082"/>
            <a:ext cx="2203370" cy="2674444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74B0E644-0E01-D516-03A6-164337A9195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4" t="56009" r="64590" b="21215"/>
          <a:stretch/>
        </p:blipFill>
        <p:spPr>
          <a:xfrm>
            <a:off x="4006854" y="1306020"/>
            <a:ext cx="2447762" cy="2704567"/>
          </a:xfrm>
          <a:prstGeom prst="rect">
            <a:avLst/>
          </a:prstGeom>
        </p:spPr>
      </p:pic>
      <p:sp>
        <p:nvSpPr>
          <p:cNvPr id="13" name="CuadroTexto 12">
            <a:extLst>
              <a:ext uri="{FF2B5EF4-FFF2-40B4-BE49-F238E27FC236}">
                <a16:creationId xmlns:a16="http://schemas.microsoft.com/office/drawing/2014/main" id="{FFE56693-2EE3-FA32-0BBA-E24324F6AF4B}"/>
              </a:ext>
            </a:extLst>
          </p:cNvPr>
          <p:cNvSpPr txBox="1"/>
          <p:nvPr/>
        </p:nvSpPr>
        <p:spPr>
          <a:xfrm>
            <a:off x="1220763" y="1693016"/>
            <a:ext cx="11643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s-ES" sz="1800" b="0" u="none" strike="noStrike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1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=0.960</a:t>
            </a:r>
            <a:endParaRPr lang="es-ES_tradnl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1D672A1E-6049-5064-4429-766D508E20D3}"/>
              </a:ext>
            </a:extLst>
          </p:cNvPr>
          <p:cNvSpPr txBox="1"/>
          <p:nvPr/>
        </p:nvSpPr>
        <p:spPr>
          <a:xfrm>
            <a:off x="4303255" y="1693016"/>
            <a:ext cx="11643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s-ES" sz="1800" b="0" u="none" strike="noStrike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1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=0.789</a:t>
            </a:r>
            <a:endParaRPr lang="es-ES_tradnl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04F36B42-3214-628E-EB61-70A5E0586374}"/>
              </a:ext>
            </a:extLst>
          </p:cNvPr>
          <p:cNvSpPr txBox="1"/>
          <p:nvPr/>
        </p:nvSpPr>
        <p:spPr>
          <a:xfrm>
            <a:off x="963282" y="4021730"/>
            <a:ext cx="167927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og2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licate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endParaRPr lang="es-ES_tradnl" sz="800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6949C47-D98C-3AAA-8DFB-3D627B1E9859}"/>
              </a:ext>
            </a:extLst>
          </p:cNvPr>
          <p:cNvSpPr txBox="1"/>
          <p:nvPr/>
        </p:nvSpPr>
        <p:spPr>
          <a:xfrm>
            <a:off x="4274487" y="3995526"/>
            <a:ext cx="167927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og2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licate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endParaRPr lang="es-ES_tradnl" sz="800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000B5D56-9B21-C60D-8298-9F6A40B2C0BE}"/>
              </a:ext>
            </a:extLst>
          </p:cNvPr>
          <p:cNvSpPr txBox="1"/>
          <p:nvPr/>
        </p:nvSpPr>
        <p:spPr>
          <a:xfrm rot="16200000">
            <a:off x="23879" y="2550581"/>
            <a:ext cx="167927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og2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licate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  <a:endParaRPr lang="es-ES_tradnl" sz="800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87CC1BB7-81D3-54B2-52AC-77FC56169175}"/>
              </a:ext>
            </a:extLst>
          </p:cNvPr>
          <p:cNvSpPr txBox="1"/>
          <p:nvPr/>
        </p:nvSpPr>
        <p:spPr>
          <a:xfrm rot="16200000">
            <a:off x="3040366" y="2564577"/>
            <a:ext cx="167927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og2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licate</a:t>
            </a:r>
            <a:r>
              <a:rPr lang="es-ES" sz="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  <a:endParaRPr lang="es-ES_tradnl" sz="800" dirty="0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667D557C-4E50-0F83-8584-F264F0D6CD51}"/>
              </a:ext>
            </a:extLst>
          </p:cNvPr>
          <p:cNvSpPr txBox="1"/>
          <p:nvPr/>
        </p:nvSpPr>
        <p:spPr>
          <a:xfrm>
            <a:off x="1934448" y="2978310"/>
            <a:ext cx="11643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800" b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lang="es-ES_tradnl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54D5ABEC-82AF-181B-E5B9-FE062AF8E8A4}"/>
              </a:ext>
            </a:extLst>
          </p:cNvPr>
          <p:cNvSpPr txBox="1"/>
          <p:nvPr/>
        </p:nvSpPr>
        <p:spPr>
          <a:xfrm>
            <a:off x="5275238" y="3027041"/>
            <a:ext cx="6294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s-ES" sz="1800" b="0" i="1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zur</a:t>
            </a:r>
            <a:endParaRPr lang="es-ES_tradnl" dirty="0"/>
          </a:p>
        </p:txBody>
      </p:sp>
    </p:spTree>
    <p:extLst>
      <p:ext uri="{BB962C8B-B14F-4D97-AF65-F5344CB8AC3E}">
        <p14:creationId xmlns:p14="http://schemas.microsoft.com/office/powerpoint/2010/main" val="6958693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96</TotalTime>
  <Words>98</Words>
  <Application>Microsoft Macintosh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ristina Sarasa  Buisan</dc:creator>
  <cp:lastModifiedBy>Ignacio Luque</cp:lastModifiedBy>
  <cp:revision>78</cp:revision>
  <dcterms:created xsi:type="dcterms:W3CDTF">2022-11-14T14:09:13Z</dcterms:created>
  <dcterms:modified xsi:type="dcterms:W3CDTF">2024-02-07T14:17:23Z</dcterms:modified>
</cp:coreProperties>
</file>